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325B5-E323-42F3-90A0-EC3CE62BB9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2C09A-F2B2-4B71-A74D-27D30442A5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A1678-548A-4EF4-A90F-749F80B1CB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326CA-AD1E-4414-A8C0-FD304A9C66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E4A3D-1A55-4390-B67A-8BFF91E080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D3D7C-E1CB-48FA-B480-06D2AD0456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8EF03-058E-4FB6-A6DC-31AE724291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3662E-972F-471E-B882-E471502DD6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3591C-B93E-49D0-9DA6-1AA62A2AF2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F9E47-3693-454C-B6FB-6DDF7AE8EA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8B29B-22B0-42E4-A46A-96BE94B60C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28CCE-5DFF-4B3F-A830-8F17545E5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FAA862-22D5-4F7C-AFAF-D23C11D7AF9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0" y="582948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7" descr=""/>
          <p:cNvPicPr/>
          <p:nvPr/>
        </p:nvPicPr>
        <p:blipFill>
          <a:blip r:embed="rId1"/>
          <a:stretch/>
        </p:blipFill>
        <p:spPr>
          <a:xfrm>
            <a:off x="898560" y="758880"/>
            <a:ext cx="7346880" cy="534024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5"/>
          <p:cNvSpPr/>
          <p:nvPr/>
        </p:nvSpPr>
        <p:spPr>
          <a:xfrm>
            <a:off x="304920" y="6095160"/>
            <a:ext cx="8610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Electrolytic Leakage of three transgenic lines and WT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Under various levels of PEG (A) and NaCl (B) with increasing of days of stress exposure (refer to Figure 1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4T18:09:22Z</dcterms:created>
  <dc:creator>Dr. Radhakrishnan</dc:creator>
  <dc:description/>
  <dc:language>en-US</dc:language>
  <cp:lastModifiedBy>Dr. Radhakrishnan</cp:lastModifiedBy>
  <dcterms:modified xsi:type="dcterms:W3CDTF">2014-11-24T18:13:04Z</dcterms:modified>
  <cp:revision>2</cp:revision>
  <dc:subject/>
  <dc:title>Slide 1</dc:title>
</cp:coreProperties>
</file>